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3753"/>
    <p:restoredTop sz="94694"/>
  </p:normalViewPr>
  <p:slideViewPr>
    <p:cSldViewPr snapToGrid="0" snapToObjects="1">
      <p:cViewPr varScale="1">
        <p:scale>
          <a:sx n="117" d="100"/>
          <a:sy n="117" d="100"/>
        </p:scale>
        <p:origin x="272" y="16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2A473-C9FA-524D-8035-4D08C37B1CEC}" type="datetimeFigureOut">
              <a:rPr kumimoji="1" lang="ja-JP" altLang="en-US" smtClean="0"/>
              <a:t>2019/5/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376F3B-AA9C-FD49-ABAC-0E91C62146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42247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2A473-C9FA-524D-8035-4D08C37B1CEC}" type="datetimeFigureOut">
              <a:rPr kumimoji="1" lang="ja-JP" altLang="en-US" smtClean="0"/>
              <a:t>2019/5/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376F3B-AA9C-FD49-ABAC-0E91C62146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22244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2A473-C9FA-524D-8035-4D08C37B1CEC}" type="datetimeFigureOut">
              <a:rPr kumimoji="1" lang="ja-JP" altLang="en-US" smtClean="0"/>
              <a:t>2019/5/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376F3B-AA9C-FD49-ABAC-0E91C62146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35985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2A473-C9FA-524D-8035-4D08C37B1CEC}" type="datetimeFigureOut">
              <a:rPr kumimoji="1" lang="ja-JP" altLang="en-US" smtClean="0"/>
              <a:t>2019/5/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376F3B-AA9C-FD49-ABAC-0E91C62146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47014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2A473-C9FA-524D-8035-4D08C37B1CEC}" type="datetimeFigureOut">
              <a:rPr kumimoji="1" lang="ja-JP" altLang="en-US" smtClean="0"/>
              <a:t>2019/5/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376F3B-AA9C-FD49-ABAC-0E91C62146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5902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2A473-C9FA-524D-8035-4D08C37B1CEC}" type="datetimeFigureOut">
              <a:rPr kumimoji="1" lang="ja-JP" altLang="en-US" smtClean="0"/>
              <a:t>2019/5/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376F3B-AA9C-FD49-ABAC-0E91C62146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36733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2A473-C9FA-524D-8035-4D08C37B1CEC}" type="datetimeFigureOut">
              <a:rPr kumimoji="1" lang="ja-JP" altLang="en-US" smtClean="0"/>
              <a:t>2019/5/2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376F3B-AA9C-FD49-ABAC-0E91C62146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85258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2A473-C9FA-524D-8035-4D08C37B1CEC}" type="datetimeFigureOut">
              <a:rPr kumimoji="1" lang="ja-JP" altLang="en-US" smtClean="0"/>
              <a:t>2019/5/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376F3B-AA9C-FD49-ABAC-0E91C62146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65859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2A473-C9FA-524D-8035-4D08C37B1CEC}" type="datetimeFigureOut">
              <a:rPr kumimoji="1" lang="ja-JP" altLang="en-US" smtClean="0"/>
              <a:t>2019/5/2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376F3B-AA9C-FD49-ABAC-0E91C62146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62522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2A473-C9FA-524D-8035-4D08C37B1CEC}" type="datetimeFigureOut">
              <a:rPr kumimoji="1" lang="ja-JP" altLang="en-US" smtClean="0"/>
              <a:t>2019/5/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376F3B-AA9C-FD49-ABAC-0E91C62146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88203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2A473-C9FA-524D-8035-4D08C37B1CEC}" type="datetimeFigureOut">
              <a:rPr kumimoji="1" lang="ja-JP" altLang="en-US" smtClean="0"/>
              <a:t>2019/5/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376F3B-AA9C-FD49-ABAC-0E91C62146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43610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32A473-C9FA-524D-8035-4D08C37B1CEC}" type="datetimeFigureOut">
              <a:rPr kumimoji="1" lang="ja-JP" altLang="en-US" smtClean="0"/>
              <a:t>2019/5/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376F3B-AA9C-FD49-ABAC-0E91C62146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79124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/>
          <p:cNvSpPr txBox="1"/>
          <p:nvPr/>
        </p:nvSpPr>
        <p:spPr>
          <a:xfrm>
            <a:off x="268111" y="5515001"/>
            <a:ext cx="870983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Additional </a:t>
            </a:r>
            <a:r>
              <a:rPr kumimoji="1" lang="en-US" altLang="ja-JP"/>
              <a:t>file 2. </a:t>
            </a:r>
            <a:r>
              <a:rPr lang="en-US" altLang="ja-JP" b="1" dirty="0"/>
              <a:t>Distribution of PIM2 against patients’ length of stay (LOS). </a:t>
            </a:r>
            <a:r>
              <a:rPr lang="en-US" altLang="ja-JP" dirty="0"/>
              <a:t>PIM2 has a negligible correlation with patients’ LOS in the entire study population (r = 0.20). Dot line indicates 15 days of LOS. Each red plot indicates a dead subject.</a:t>
            </a:r>
            <a:r>
              <a:rPr lang="ja-JP" altLang="ja-JP" dirty="0"/>
              <a:t> </a:t>
            </a:r>
            <a:r>
              <a:rPr lang="en-US" altLang="ja-JP" dirty="0"/>
              <a:t>Seven data points are outside the x-axis limits. </a:t>
            </a:r>
            <a:endParaRPr kumimoji="1" lang="ja-JP" altLang="en-US" dirty="0"/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1341" y="183446"/>
            <a:ext cx="7841319" cy="53636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39332551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7</TotalTime>
  <Words>60</Words>
  <Application>Microsoft Macintosh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ホワイト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野坂 宜之</dc:creator>
  <cp:lastModifiedBy>Nosaka, Nobuyuki</cp:lastModifiedBy>
  <cp:revision>10</cp:revision>
  <dcterms:created xsi:type="dcterms:W3CDTF">2018-12-27T06:54:20Z</dcterms:created>
  <dcterms:modified xsi:type="dcterms:W3CDTF">2019-05-02T20:58:00Z</dcterms:modified>
</cp:coreProperties>
</file>